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74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36512" y="1556792"/>
            <a:ext cx="2595387" cy="5092618"/>
            <a:chOff x="2915816" y="836712"/>
            <a:chExt cx="2595387" cy="509261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 cstate="print">
              <a:lum bright="-20000"/>
            </a:blip>
            <a:srcRect l="36926" t="15874" r="32404" b="28562"/>
            <a:stretch>
              <a:fillRect/>
            </a:stretch>
          </p:blipFill>
          <p:spPr bwMode="auto">
            <a:xfrm>
              <a:off x="3779912" y="1142984"/>
              <a:ext cx="1656184" cy="20002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7"/>
            <p:cNvPicPr>
              <a:picLocks noChangeAspect="1" noChangeArrowheads="1"/>
            </p:cNvPicPr>
            <p:nvPr/>
          </p:nvPicPr>
          <p:blipFill>
            <a:blip r:embed="rId3" cstate="print">
              <a:lum bright="-20000"/>
            </a:blip>
            <a:srcRect l="40884" t="15875" r="25779" b="26578"/>
            <a:stretch>
              <a:fillRect/>
            </a:stretch>
          </p:blipFill>
          <p:spPr bwMode="auto">
            <a:xfrm>
              <a:off x="3707904" y="3857628"/>
              <a:ext cx="1800200" cy="20717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2915816" y="836712"/>
              <a:ext cx="2071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 smtClean="0"/>
                <a:t>Spectrin</a:t>
              </a:r>
              <a:endParaRPr lang="en-US" dirty="0"/>
            </a:p>
          </p:txBody>
        </p:sp>
        <p:sp>
          <p:nvSpPr>
            <p:cNvPr id="6" name="Rectangle 5"/>
            <p:cNvSpPr/>
            <p:nvPr/>
          </p:nvSpPr>
          <p:spPr>
            <a:xfrm rot="19174686">
              <a:off x="3709363" y="1339665"/>
              <a:ext cx="63030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LADDER 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 rot="19174686">
              <a:off x="4091617" y="1442047"/>
              <a:ext cx="42030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Adult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 rot="19174686">
              <a:off x="4439241" y="1403069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96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 rot="19174686">
              <a:off x="5010745" y="1403069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8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 rot="19174686">
              <a:off x="4724993" y="1422397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72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 rot="19174686">
              <a:off x="3688737" y="3422915"/>
              <a:ext cx="63030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LADDER 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 rot="19174686">
              <a:off x="4070991" y="3525297"/>
              <a:ext cx="42030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Adult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 rot="19174686">
              <a:off x="4418615" y="3486319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96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 rot="19174686">
              <a:off x="4990119" y="3486319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8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 rot="19174686">
              <a:off x="4704367" y="3505647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72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987824" y="3212976"/>
              <a:ext cx="2071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IP</a:t>
              </a:r>
              <a:r>
                <a:rPr lang="en-US" baseline="-25000" dirty="0" smtClean="0"/>
                <a:t>3</a:t>
              </a:r>
              <a:r>
                <a:rPr lang="en-US" dirty="0" smtClean="0"/>
                <a:t>R</a:t>
              </a:r>
              <a:endParaRPr lang="en-US" dirty="0"/>
            </a:p>
          </p:txBody>
        </p:sp>
      </p:grpSp>
      <p:sp>
        <p:nvSpPr>
          <p:cNvPr id="21" name="Rectangle 20"/>
          <p:cNvSpPr/>
          <p:nvPr/>
        </p:nvSpPr>
        <p:spPr>
          <a:xfrm rot="19174686">
            <a:off x="3651200" y="2023457"/>
            <a:ext cx="63030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LADDER 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 rot="19174686">
            <a:off x="4033454" y="2125839"/>
            <a:ext cx="42030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Adult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 rot="19174686">
            <a:off x="4381078" y="2086861"/>
            <a:ext cx="50045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96APF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 rot="19174686">
            <a:off x="4952582" y="2086861"/>
            <a:ext cx="50045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48APF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 rot="19174686">
            <a:off x="4666830" y="2106189"/>
            <a:ext cx="50045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72APF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1" name="Group 30"/>
          <p:cNvGrpSpPr/>
          <p:nvPr/>
        </p:nvGrpSpPr>
        <p:grpSpPr>
          <a:xfrm>
            <a:off x="6588224" y="1965507"/>
            <a:ext cx="2160240" cy="4271805"/>
            <a:chOff x="1547664" y="1196789"/>
            <a:chExt cx="2160240" cy="4271805"/>
          </a:xfrm>
        </p:grpSpPr>
        <p:pic>
          <p:nvPicPr>
            <p:cNvPr id="32" name="Picture 4"/>
            <p:cNvPicPr>
              <a:picLocks noChangeAspect="1" noChangeArrowheads="1"/>
            </p:cNvPicPr>
            <p:nvPr/>
          </p:nvPicPr>
          <p:blipFill>
            <a:blip r:embed="rId4" cstate="print">
              <a:lum bright="-20000"/>
            </a:blip>
            <a:srcRect l="21515" t="29766" r="39814" b="26578"/>
            <a:stretch>
              <a:fillRect/>
            </a:stretch>
          </p:blipFill>
          <p:spPr bwMode="auto">
            <a:xfrm>
              <a:off x="1619672" y="1214422"/>
              <a:ext cx="2088232" cy="15716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4" name="Rectangle 33"/>
            <p:cNvSpPr/>
            <p:nvPr/>
          </p:nvSpPr>
          <p:spPr>
            <a:xfrm rot="19174686">
              <a:off x="1709099" y="1196789"/>
              <a:ext cx="63030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LADDER 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34"/>
            <p:cNvSpPr/>
            <p:nvPr/>
          </p:nvSpPr>
          <p:spPr>
            <a:xfrm rot="19174686">
              <a:off x="2091353" y="1299171"/>
              <a:ext cx="42030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Adult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35"/>
            <p:cNvSpPr/>
            <p:nvPr/>
          </p:nvSpPr>
          <p:spPr>
            <a:xfrm rot="19174686">
              <a:off x="2438977" y="1260193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96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ctangle 36"/>
            <p:cNvSpPr/>
            <p:nvPr/>
          </p:nvSpPr>
          <p:spPr>
            <a:xfrm rot="19174686">
              <a:off x="3010481" y="1260193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8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ctangle 37"/>
            <p:cNvSpPr/>
            <p:nvPr/>
          </p:nvSpPr>
          <p:spPr>
            <a:xfrm rot="19174686">
              <a:off x="2724729" y="1279521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72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9" name="Group 20"/>
            <p:cNvGrpSpPr/>
            <p:nvPr/>
          </p:nvGrpSpPr>
          <p:grpSpPr>
            <a:xfrm>
              <a:off x="1547664" y="3390807"/>
              <a:ext cx="1944216" cy="2077787"/>
              <a:chOff x="1547664" y="3390807"/>
              <a:chExt cx="1944216" cy="2077787"/>
            </a:xfrm>
          </p:grpSpPr>
          <p:pic>
            <p:nvPicPr>
              <p:cNvPr id="40" name="Picture 5"/>
              <p:cNvPicPr>
                <a:picLocks noChangeAspect="1" noChangeArrowheads="1"/>
              </p:cNvPicPr>
              <p:nvPr/>
            </p:nvPicPr>
            <p:blipFill>
              <a:blip r:embed="rId5" cstate="print">
                <a:lum bright="-20000"/>
              </a:blip>
              <a:srcRect l="22046" t="21828" r="41950" b="30546"/>
              <a:stretch>
                <a:fillRect/>
              </a:stretch>
            </p:blipFill>
            <p:spPr bwMode="auto">
              <a:xfrm>
                <a:off x="1547664" y="3754082"/>
                <a:ext cx="1944216" cy="17145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41" name="Rectangle 40"/>
              <p:cNvSpPr/>
              <p:nvPr/>
            </p:nvSpPr>
            <p:spPr>
              <a:xfrm rot="19174686">
                <a:off x="1617035" y="3390807"/>
                <a:ext cx="63030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LADDER 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 rot="19174686">
                <a:off x="1999289" y="3493189"/>
                <a:ext cx="42030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Adult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ctangle 42"/>
              <p:cNvSpPr/>
              <p:nvPr/>
            </p:nvSpPr>
            <p:spPr>
              <a:xfrm rot="19174686">
                <a:off x="2346913" y="3454211"/>
                <a:ext cx="50045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96APF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ctangle 43"/>
              <p:cNvSpPr/>
              <p:nvPr/>
            </p:nvSpPr>
            <p:spPr>
              <a:xfrm rot="19174686">
                <a:off x="2918417" y="3454211"/>
                <a:ext cx="50045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48APF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ctangle 44"/>
              <p:cNvSpPr/>
              <p:nvPr/>
            </p:nvSpPr>
            <p:spPr>
              <a:xfrm rot="19174686">
                <a:off x="2632665" y="3473539"/>
                <a:ext cx="50045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72APF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47" name="TextBox 46"/>
          <p:cNvSpPr txBox="1"/>
          <p:nvPr/>
        </p:nvSpPr>
        <p:spPr>
          <a:xfrm>
            <a:off x="1259632" y="1187460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lot1</a:t>
            </a:r>
            <a:endParaRPr lang="en-US" dirty="0"/>
          </a:p>
        </p:txBody>
      </p:sp>
      <p:sp>
        <p:nvSpPr>
          <p:cNvPr id="48" name="TextBox 47"/>
          <p:cNvSpPr txBox="1"/>
          <p:nvPr/>
        </p:nvSpPr>
        <p:spPr>
          <a:xfrm>
            <a:off x="4139952" y="1187460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lot2 and 3</a:t>
            </a:r>
            <a:endParaRPr lang="en-US" dirty="0"/>
          </a:p>
        </p:txBody>
      </p:sp>
      <p:sp>
        <p:nvSpPr>
          <p:cNvPr id="49" name="TextBox 48"/>
          <p:cNvSpPr txBox="1"/>
          <p:nvPr/>
        </p:nvSpPr>
        <p:spPr>
          <a:xfrm>
            <a:off x="6372200" y="1187460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lot4</a:t>
            </a:r>
            <a:endParaRPr lang="en-US" dirty="0"/>
          </a:p>
        </p:txBody>
      </p:sp>
      <p:sp>
        <p:nvSpPr>
          <p:cNvPr id="50" name="TextBox 49"/>
          <p:cNvSpPr txBox="1"/>
          <p:nvPr/>
        </p:nvSpPr>
        <p:spPr>
          <a:xfrm>
            <a:off x="2699792" y="188640"/>
            <a:ext cx="3744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lots for </a:t>
            </a:r>
            <a:r>
              <a:rPr lang="en-IN" smtClean="0"/>
              <a:t>Figure </a:t>
            </a:r>
            <a:r>
              <a:rPr lang="en-IN" smtClean="0"/>
              <a:t>3C </a:t>
            </a:r>
            <a:endParaRPr lang="en-US" dirty="0"/>
          </a:p>
        </p:txBody>
      </p:sp>
      <p:pic>
        <p:nvPicPr>
          <p:cNvPr id="51" name="Picture 5"/>
          <p:cNvPicPr>
            <a:picLocks noChangeAspect="1" noChangeArrowheads="1"/>
          </p:cNvPicPr>
          <p:nvPr/>
        </p:nvPicPr>
        <p:blipFill>
          <a:blip r:embed="rId6" cstate="print">
            <a:lum bright="-20000"/>
          </a:blip>
          <a:srcRect l="20672" t="15504" r="24696" b="34663"/>
          <a:stretch>
            <a:fillRect/>
          </a:stretch>
        </p:blipFill>
        <p:spPr bwMode="auto">
          <a:xfrm>
            <a:off x="2759581" y="4630136"/>
            <a:ext cx="3234978" cy="1967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57" name="Group 56"/>
          <p:cNvGrpSpPr/>
          <p:nvPr/>
        </p:nvGrpSpPr>
        <p:grpSpPr>
          <a:xfrm>
            <a:off x="3007507" y="4327713"/>
            <a:ext cx="2922528" cy="284334"/>
            <a:chOff x="3007507" y="4327713"/>
            <a:chExt cx="2922528" cy="284334"/>
          </a:xfrm>
        </p:grpSpPr>
        <p:sp>
          <p:nvSpPr>
            <p:cNvPr id="26" name="Rectangle 25"/>
            <p:cNvSpPr/>
            <p:nvPr/>
          </p:nvSpPr>
          <p:spPr>
            <a:xfrm rot="19174686">
              <a:off x="4206579" y="4327713"/>
              <a:ext cx="63030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LADDER 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 rot="19174686">
              <a:off x="4510449" y="4392813"/>
              <a:ext cx="42030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Adult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27"/>
            <p:cNvSpPr/>
            <p:nvPr/>
          </p:nvSpPr>
          <p:spPr>
            <a:xfrm rot="19174686">
              <a:off x="4858073" y="4353835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96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 rot="19174686">
              <a:off x="5429577" y="4353835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8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 rot="19174686">
              <a:off x="5143825" y="4373163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72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52"/>
            <p:cNvSpPr/>
            <p:nvPr/>
          </p:nvSpPr>
          <p:spPr>
            <a:xfrm rot="19174686">
              <a:off x="3007507" y="4396603"/>
              <a:ext cx="42030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Adult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53"/>
            <p:cNvSpPr/>
            <p:nvPr/>
          </p:nvSpPr>
          <p:spPr>
            <a:xfrm rot="19174686">
              <a:off x="3355131" y="4357625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96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ctangle 54"/>
            <p:cNvSpPr/>
            <p:nvPr/>
          </p:nvSpPr>
          <p:spPr>
            <a:xfrm rot="19174686">
              <a:off x="3926635" y="4357625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8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ctangle 55"/>
            <p:cNvSpPr/>
            <p:nvPr/>
          </p:nvSpPr>
          <p:spPr>
            <a:xfrm rot="19174686">
              <a:off x="3640883" y="4376953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72APF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8" name="Group 67"/>
          <p:cNvGrpSpPr/>
          <p:nvPr/>
        </p:nvGrpSpPr>
        <p:grpSpPr>
          <a:xfrm>
            <a:off x="2843808" y="1788418"/>
            <a:ext cx="3366128" cy="2360662"/>
            <a:chOff x="2843808" y="1844824"/>
            <a:chExt cx="3366128" cy="2360662"/>
          </a:xfrm>
        </p:grpSpPr>
        <p:pic>
          <p:nvPicPr>
            <p:cNvPr id="52" name="Picture 7"/>
            <p:cNvPicPr>
              <a:picLocks noChangeAspect="1" noChangeArrowheads="1"/>
            </p:cNvPicPr>
            <p:nvPr/>
          </p:nvPicPr>
          <p:blipFill>
            <a:blip r:embed="rId7" cstate="print">
              <a:lum bright="-20000"/>
            </a:blip>
            <a:srcRect l="24160" t="15670" r="18993" b="24530"/>
            <a:stretch>
              <a:fillRect/>
            </a:stretch>
          </p:blipFill>
          <p:spPr bwMode="auto">
            <a:xfrm>
              <a:off x="2843808" y="1844824"/>
              <a:ext cx="3366128" cy="23606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58" name="Group 57"/>
            <p:cNvGrpSpPr/>
            <p:nvPr/>
          </p:nvGrpSpPr>
          <p:grpSpPr>
            <a:xfrm>
              <a:off x="3089632" y="2276872"/>
              <a:ext cx="2922528" cy="284334"/>
              <a:chOff x="3007507" y="4327713"/>
              <a:chExt cx="2922528" cy="284334"/>
            </a:xfrm>
          </p:grpSpPr>
          <p:sp>
            <p:nvSpPr>
              <p:cNvPr id="59" name="Rectangle 58"/>
              <p:cNvSpPr/>
              <p:nvPr/>
            </p:nvSpPr>
            <p:spPr>
              <a:xfrm rot="19174686">
                <a:off x="4206579" y="4327713"/>
                <a:ext cx="63030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LADDER 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59"/>
              <p:cNvSpPr/>
              <p:nvPr/>
            </p:nvSpPr>
            <p:spPr>
              <a:xfrm rot="19174686">
                <a:off x="4510449" y="4392813"/>
                <a:ext cx="42030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Adult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60"/>
              <p:cNvSpPr/>
              <p:nvPr/>
            </p:nvSpPr>
            <p:spPr>
              <a:xfrm rot="19174686">
                <a:off x="4858073" y="4353835"/>
                <a:ext cx="50045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96APF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 rot="19174686">
                <a:off x="5429577" y="4353835"/>
                <a:ext cx="50045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48APF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 rot="19174686">
                <a:off x="5143825" y="4373163"/>
                <a:ext cx="50045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72APF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 rot="19174686">
                <a:off x="3007507" y="4396603"/>
                <a:ext cx="42030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Adult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ctangle 64"/>
              <p:cNvSpPr/>
              <p:nvPr/>
            </p:nvSpPr>
            <p:spPr>
              <a:xfrm rot="19174686">
                <a:off x="3355131" y="4357625"/>
                <a:ext cx="50045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96APF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ctangle 65"/>
              <p:cNvSpPr/>
              <p:nvPr/>
            </p:nvSpPr>
            <p:spPr>
              <a:xfrm rot="19174686">
                <a:off x="3926635" y="4357625"/>
                <a:ext cx="50045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48APF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66"/>
              <p:cNvSpPr/>
              <p:nvPr/>
            </p:nvSpPr>
            <p:spPr>
              <a:xfrm rot="19174686">
                <a:off x="3640883" y="4376953"/>
                <a:ext cx="50045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72APF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54</Words>
  <Application>Microsoft Office PowerPoint</Application>
  <PresentationFormat>On-screen Show (4:3)</PresentationFormat>
  <Paragraphs>4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AMIKA SHARMA</dc:creator>
  <cp:lastModifiedBy>ANAMIKA SHARMA</cp:lastModifiedBy>
  <cp:revision>15</cp:revision>
  <dcterms:created xsi:type="dcterms:W3CDTF">2020-08-27T12:47:35Z</dcterms:created>
  <dcterms:modified xsi:type="dcterms:W3CDTF">2020-10-13T02:49:41Z</dcterms:modified>
</cp:coreProperties>
</file>